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4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74868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4"/>
          <p:cNvSpPr txBox="1"/>
          <p:nvPr/>
        </p:nvSpPr>
        <p:spPr>
          <a:xfrm>
            <a:off x="343140" y="5573787"/>
            <a:ext cx="612862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upplemental Figure S8. Structure-based sequence alignment of KSHV ORF57 and </a:t>
            </a: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its </a:t>
            </a: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homologues.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Multiple alignment of the protein sequences was performed by </a:t>
            </a:r>
            <a:r>
              <a:rPr lang="en-US" altLang="zh-CN" sz="1000" dirty="0" err="1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Clustal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Omega for</a:t>
            </a:r>
            <a:r>
              <a:rPr lang="en-US" altLang="zh-CN" sz="1000" dirty="0">
                <a:solidFill>
                  <a:srgbClr val="00B05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ICP27 (herpes simplex virus type 1 and type 2, HSV1-ICP27 and HSV2-ICP27), ORF4 (varicella-zoster virus, VZV-ORF4), EB2 (Epstein-Barr virus, EBV-EB2), UL69 (human cytomegalovirus, HCMV-UL69), and mORF57 (murine gamma herpesvirus 68, MHV68-mORF57), with the conserved residues in red surrounded by blue boxes, identical residues in red, and the residues of the zinc-binding motif in red stars. The secondary structural elements of ORF57-CTD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were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analyzed by ESPript3</a:t>
            </a:r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(http://espript.ibcp.fr/ESPript/cgi-bin/ESPript.cgi),</a:t>
            </a:r>
            <a:r>
              <a:rPr lang="en-US" altLang="zh-CN" sz="1000" dirty="0">
                <a:solidFill>
                  <a:srgbClr val="00B05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with the indicated </a:t>
            </a:r>
            <a:r>
              <a:rPr lang="el-GR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α-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helix (coil), </a:t>
            </a:r>
            <a:r>
              <a:rPr lang="el-GR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η-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helix (coil), </a:t>
            </a:r>
            <a:r>
              <a:rPr lang="el-GR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β-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sheet (arrows), and turn (T) above the alignment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37" y="665746"/>
            <a:ext cx="6779063" cy="4908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6163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6</TotalTime>
  <Words>142</Words>
  <Application>Microsoft Office PowerPoint</Application>
  <PresentationFormat>全屏显示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5</cp:revision>
  <cp:lastPrinted>2018-01-18T18:33:05Z</cp:lastPrinted>
  <dcterms:created xsi:type="dcterms:W3CDTF">2017-06-08T22:39:00Z</dcterms:created>
  <dcterms:modified xsi:type="dcterms:W3CDTF">2018-07-26T12:44:19Z</dcterms:modified>
</cp:coreProperties>
</file>